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1" d="100"/>
          <a:sy n="101" d="100"/>
        </p:scale>
        <p:origin x="-22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41232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85412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3001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3336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4933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1123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971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1339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3600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6441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8969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B0624-35E6-4E5C-889B-6A9B96790ACF}" type="datetimeFigureOut">
              <a:rPr lang="en-CA" smtClean="0"/>
              <a:t>2014-05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B9689-3211-4478-BA33-E408D5C87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2550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20101" y="1196752"/>
            <a:ext cx="8893175" cy="5545137"/>
            <a:chOff x="120101" y="1196752"/>
            <a:chExt cx="8893175" cy="5545137"/>
          </a:xfrm>
        </p:grpSpPr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0101" y="1196752"/>
              <a:ext cx="8893175" cy="55451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251520" y="5283413"/>
              <a:ext cx="849694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dirty="0" smtClean="0"/>
                <a:t>Figure_S1. Cluster </a:t>
              </a:r>
              <a:r>
                <a:rPr lang="en-CA" sz="1400" dirty="0" smtClean="0"/>
                <a:t>analysis.</a:t>
              </a:r>
              <a:r>
                <a:rPr lang="en-CA" sz="1400" dirty="0"/>
                <a:t> </a:t>
              </a:r>
              <a:r>
                <a:rPr lang="en-CA" sz="1400" dirty="0" smtClean="0"/>
                <a:t>All </a:t>
              </a:r>
              <a:r>
                <a:rPr lang="en-CA" sz="1400" dirty="0"/>
                <a:t>50 samples </a:t>
              </a:r>
              <a:r>
                <a:rPr lang="en-CA" sz="1400" dirty="0" smtClean="0"/>
                <a:t>with </a:t>
              </a:r>
              <a:r>
                <a:rPr lang="en-CA" sz="1400" dirty="0"/>
                <a:t>all significantly changed </a:t>
              </a:r>
              <a:r>
                <a:rPr lang="en-CA" sz="1400" dirty="0" smtClean="0"/>
                <a:t>genes in 5 dose groups were input into </a:t>
              </a:r>
              <a:r>
                <a:rPr lang="en-CA" sz="1400" dirty="0" err="1" smtClean="0"/>
                <a:t>GeneSpring</a:t>
              </a:r>
              <a:r>
                <a:rPr lang="en-CA" sz="1400" dirty="0" smtClean="0"/>
                <a:t>. The results </a:t>
              </a:r>
              <a:r>
                <a:rPr lang="en-CA" sz="1400" dirty="0"/>
                <a:t>indicated that all samples were distinctly split into two groups determined by </a:t>
              </a:r>
              <a:r>
                <a:rPr lang="en-CA" sz="1400" dirty="0" smtClean="0"/>
                <a:t>sex.</a:t>
              </a:r>
              <a:endParaRPr lang="en-CA" sz="14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87824" y="5003884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/>
                <a:t>male</a:t>
              </a:r>
              <a:endParaRPr lang="en-CA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518796" y="5003884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/>
                <a:t>female</a:t>
              </a:r>
              <a:endParaRPr lang="en-CA" dirty="0"/>
            </a:p>
          </p:txBody>
        </p:sp>
        <p:sp>
          <p:nvSpPr>
            <p:cNvPr id="2" name="Rectangle 1"/>
            <p:cNvSpPr/>
            <p:nvPr/>
          </p:nvSpPr>
          <p:spPr>
            <a:xfrm>
              <a:off x="251520" y="6309320"/>
              <a:ext cx="8640960" cy="360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</p:spTree>
    <p:extLst>
      <p:ext uri="{BB962C8B-B14F-4D97-AF65-F5344CB8AC3E}">
        <p14:creationId xmlns:p14="http://schemas.microsoft.com/office/powerpoint/2010/main" val="3132300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alth Canada - Santé Cana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cuser</dc:creator>
  <cp:lastModifiedBy>hcuser</cp:lastModifiedBy>
  <cp:revision>2</cp:revision>
  <dcterms:created xsi:type="dcterms:W3CDTF">2014-04-22T20:55:07Z</dcterms:created>
  <dcterms:modified xsi:type="dcterms:W3CDTF">2014-05-21T17:51:08Z</dcterms:modified>
</cp:coreProperties>
</file>